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257" r:id="rId4"/>
    <p:sldId id="264" r:id="rId5"/>
    <p:sldId id="258" r:id="rId6"/>
    <p:sldId id="266" r:id="rId7"/>
    <p:sldId id="269" r:id="rId8"/>
    <p:sldId id="260" r:id="rId9"/>
    <p:sldId id="261" r:id="rId10"/>
    <p:sldId id="262" r:id="rId11"/>
    <p:sldId id="267" r:id="rId1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121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tiff"/><Relationship Id="rId4" Type="http://schemas.openxmlformats.org/officeDocument/2006/relationships/image" Target="../media/image2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igure 3a isw1 Kac raw data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539552" y="2204864"/>
            <a:ext cx="3420687" cy="2556164"/>
          </a:xfrm>
          <a:prstGeom prst="rect">
            <a:avLst/>
          </a:prstGeom>
        </p:spPr>
      </p:pic>
      <p:pic>
        <p:nvPicPr>
          <p:cNvPr id="5" name="图片 4" descr="Figure 3a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5004048" y="2132856"/>
            <a:ext cx="3420687" cy="255616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a </a:t>
            </a:r>
            <a:r>
              <a:rPr lang="en-GB" altLang="zh-CN" sz="1200" dirty="0" err="1" smtClean="0"/>
              <a:t>Acetylation</a:t>
            </a:r>
            <a:r>
              <a:rPr lang="en-GB" altLang="zh-CN" sz="1200" dirty="0" smtClean="0"/>
              <a:t> analysis of Isw1 </a:t>
            </a:r>
            <a:endParaRPr lang="en-GB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8" name="矩形 7"/>
          <p:cNvSpPr/>
          <p:nvPr/>
        </p:nvSpPr>
        <p:spPr>
          <a:xfrm>
            <a:off x="2267744" y="3140968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677919" y="2464071"/>
            <a:ext cx="7745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03601" y="254101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363641" y="2558596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189428" y="254101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 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339752" y="2348880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376063" y="2071881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4067944" y="3068960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Kac</a:t>
            </a:r>
            <a:endParaRPr lang="en-US" sz="1200" dirty="0" smtClean="0"/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16" name="右大括号 15"/>
          <p:cNvSpPr/>
          <p:nvPr/>
        </p:nvSpPr>
        <p:spPr>
          <a:xfrm>
            <a:off x="3563888" y="2996952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7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3131840" y="328498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6156176" y="3255367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504971" y="2625667"/>
            <a:ext cx="7745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892033" y="2702612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252073" y="2702612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077860" y="2702612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 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228184" y="2463279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264495" y="2215897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884368" y="3140968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26" name="右大括号 25"/>
          <p:cNvSpPr/>
          <p:nvPr/>
        </p:nvSpPr>
        <p:spPr>
          <a:xfrm>
            <a:off x="7452320" y="3111351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7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7020272" y="3399383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308304" y="472514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P:Isw1-Flag</a:t>
            </a:r>
            <a:endParaRPr lang="en-GB" sz="12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ure 3i histone raw data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4427984" y="1844988"/>
            <a:ext cx="3418531" cy="2556000"/>
          </a:xfrm>
          <a:prstGeom prst="rect">
            <a:avLst/>
          </a:prstGeom>
        </p:spPr>
      </p:pic>
      <p:pic>
        <p:nvPicPr>
          <p:cNvPr id="3" name="图片 2" descr="Figure 3i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395536" y="1844824"/>
            <a:ext cx="3420687" cy="25561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484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</a:t>
            </a:r>
            <a:r>
              <a:rPr lang="en-US" altLang="zh-CN" sz="1200" dirty="0" err="1" smtClean="0"/>
              <a:t>i</a:t>
            </a:r>
            <a:r>
              <a:rPr lang="en-GB" sz="1200" dirty="0" smtClean="0"/>
              <a:t> </a:t>
            </a:r>
            <a:r>
              <a:rPr lang="en-GB" altLang="zh-CN" sz="1200" dirty="0" smtClean="0"/>
              <a:t> Isw1 K97R protein stability</a:t>
            </a:r>
            <a:endParaRPr lang="en-GB" altLang="zh-CN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6" name="矩形 5"/>
          <p:cNvSpPr/>
          <p:nvPr/>
        </p:nvSpPr>
        <p:spPr>
          <a:xfrm>
            <a:off x="2051720" y="2780928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右大括号 6"/>
          <p:cNvSpPr/>
          <p:nvPr/>
        </p:nvSpPr>
        <p:spPr>
          <a:xfrm>
            <a:off x="3059832" y="2636911"/>
            <a:ext cx="288032" cy="504057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2843808" y="2863969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419872" y="2679303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Flag</a:t>
            </a:r>
          </a:p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b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123727" y="1700808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Isw1-Flag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123727" y="1999873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1118324" y="2215897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793094" y="2114484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45122" y="2222495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189138" y="2150487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441166" y="2186491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5868145" y="3140968"/>
            <a:ext cx="720080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6729531" y="328498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308304" y="2996952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868144" y="2143889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Isw1-Flag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934734" y="2438469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4929331" y="2654493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604101" y="2553080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861546" y="2661091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933554" y="2589083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185582" y="2625087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右大括号 26"/>
          <p:cNvSpPr/>
          <p:nvPr/>
        </p:nvSpPr>
        <p:spPr>
          <a:xfrm>
            <a:off x="6948264" y="2985919"/>
            <a:ext cx="288032" cy="515089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 descr="flag 2.ti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827584" y="3429000"/>
            <a:ext cx="3419856" cy="2554224"/>
          </a:xfrm>
          <a:prstGeom prst="rect">
            <a:avLst/>
          </a:prstGeom>
        </p:spPr>
      </p:pic>
      <p:pic>
        <p:nvPicPr>
          <p:cNvPr id="31" name="图片 30" descr="histone 2.ti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5004048" y="3501008"/>
            <a:ext cx="3419856" cy="2554224"/>
          </a:xfrm>
          <a:prstGeom prst="rect">
            <a:avLst/>
          </a:prstGeom>
        </p:spPr>
      </p:pic>
      <p:pic>
        <p:nvPicPr>
          <p:cNvPr id="28" name="图片 27" descr="flag 1.tif"/>
          <p:cNvPicPr>
            <a:picLocks noChangeAspect="1"/>
          </p:cNvPicPr>
          <p:nvPr/>
        </p:nvPicPr>
        <p:blipFill>
          <a:blip r:embed="rId4" cstate="print">
            <a:lum contrast="-10000"/>
          </a:blip>
          <a:stretch>
            <a:fillRect/>
          </a:stretch>
        </p:blipFill>
        <p:spPr>
          <a:xfrm>
            <a:off x="864112" y="692696"/>
            <a:ext cx="3419856" cy="2554224"/>
          </a:xfrm>
          <a:prstGeom prst="rect">
            <a:avLst/>
          </a:prstGeom>
        </p:spPr>
      </p:pic>
      <p:pic>
        <p:nvPicPr>
          <p:cNvPr id="29" name="图片 28" descr="histone 1.tif"/>
          <p:cNvPicPr>
            <a:picLocks noChangeAspect="1"/>
          </p:cNvPicPr>
          <p:nvPr/>
        </p:nvPicPr>
        <p:blipFill>
          <a:blip r:embed="rId5" cstate="print">
            <a:lum contrast="-10000"/>
          </a:blip>
          <a:stretch>
            <a:fillRect/>
          </a:stretch>
        </p:blipFill>
        <p:spPr>
          <a:xfrm>
            <a:off x="5004048" y="730760"/>
            <a:ext cx="3419856" cy="25542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484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</a:t>
            </a:r>
            <a:r>
              <a:rPr lang="en-US" altLang="zh-CN" sz="1200" dirty="0" err="1" smtClean="0"/>
              <a:t>i</a:t>
            </a:r>
            <a:r>
              <a:rPr lang="en-GB" sz="1200" dirty="0" smtClean="0"/>
              <a:t> </a:t>
            </a:r>
            <a:r>
              <a:rPr lang="en-GB" altLang="zh-CN" sz="1200" dirty="0" smtClean="0"/>
              <a:t> Isw1 K97R protein stability</a:t>
            </a:r>
            <a:endParaRPr lang="en-GB" altLang="zh-CN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7" name="右大括号 6"/>
          <p:cNvSpPr/>
          <p:nvPr/>
        </p:nvSpPr>
        <p:spPr>
          <a:xfrm>
            <a:off x="3456384" y="1880947"/>
            <a:ext cx="288032" cy="504057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816424" y="1923339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Flag</a:t>
            </a:r>
          </a:p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b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520279" y="94484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Isw1-Flag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520279" y="1243909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1514876" y="1459933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189646" y="1358520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441674" y="1466531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85690" y="1394523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837718" y="1430527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704856" y="1880948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264696" y="1027885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Isw1-Flag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331286" y="1322465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5325883" y="1538489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000653" y="1437076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258098" y="1545087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330106" y="1473079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582134" y="1509083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右大括号 26"/>
          <p:cNvSpPr/>
          <p:nvPr/>
        </p:nvSpPr>
        <p:spPr>
          <a:xfrm>
            <a:off x="7344816" y="1869915"/>
            <a:ext cx="288032" cy="515089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右大括号 32"/>
          <p:cNvSpPr/>
          <p:nvPr/>
        </p:nvSpPr>
        <p:spPr>
          <a:xfrm>
            <a:off x="3347864" y="4149079"/>
            <a:ext cx="288032" cy="504057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707904" y="4191471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Flag</a:t>
            </a:r>
          </a:p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b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411759" y="321297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Isw1-Flag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411759" y="3512041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/>
          <p:cNvSpPr/>
          <p:nvPr/>
        </p:nvSpPr>
        <p:spPr>
          <a:xfrm>
            <a:off x="1406356" y="3728065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81126" y="3626652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333154" y="3734663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477170" y="3662655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729198" y="3698659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671053" y="4354071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230893" y="3501008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Isw1-Flag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7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297483" y="379558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矩形 47"/>
          <p:cNvSpPr/>
          <p:nvPr/>
        </p:nvSpPr>
        <p:spPr>
          <a:xfrm>
            <a:off x="5292080" y="4011612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966850" y="3910199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224295" y="401821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296303" y="3946202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548331" y="398220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右大括号 52"/>
          <p:cNvSpPr/>
          <p:nvPr/>
        </p:nvSpPr>
        <p:spPr>
          <a:xfrm>
            <a:off x="7311013" y="4343038"/>
            <a:ext cx="288032" cy="515089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E:\数据数据数据数据\2023 02 13补充数据\补充数据 ai excel word\FLC FLAG 1.tif"/>
          <p:cNvPicPr>
            <a:picLocks noChangeAspect="1" noChangeArrowheads="1"/>
          </p:cNvPicPr>
          <p:nvPr/>
        </p:nvPicPr>
        <p:blipFill>
          <a:blip r:embed="rId2" cstate="print">
            <a:lum contrast="-10000"/>
          </a:blip>
          <a:srcRect/>
          <a:stretch>
            <a:fillRect/>
          </a:stretch>
        </p:blipFill>
        <p:spPr bwMode="auto">
          <a:xfrm>
            <a:off x="4283968" y="946721"/>
            <a:ext cx="3419475" cy="2554288"/>
          </a:xfrm>
          <a:prstGeom prst="rect">
            <a:avLst/>
          </a:prstGeom>
          <a:noFill/>
        </p:spPr>
      </p:pic>
      <p:pic>
        <p:nvPicPr>
          <p:cNvPr id="2" name="Picture 2" descr="E:\数据数据数据数据\2023 02 13补充数据\补充数据 ai excel word\FLC KAC 1.tif"/>
          <p:cNvPicPr>
            <a:picLocks noChangeAspect="1" noChangeArrowheads="1"/>
          </p:cNvPicPr>
          <p:nvPr/>
        </p:nvPicPr>
        <p:blipFill>
          <a:blip r:embed="rId3" cstate="print">
            <a:lum contrast="-10000"/>
          </a:blip>
          <a:srcRect/>
          <a:stretch>
            <a:fillRect/>
          </a:stretch>
        </p:blipFill>
        <p:spPr bwMode="auto">
          <a:xfrm>
            <a:off x="755576" y="946721"/>
            <a:ext cx="3419475" cy="2554287"/>
          </a:xfrm>
          <a:prstGeom prst="rect">
            <a:avLst/>
          </a:prstGeom>
          <a:noFill/>
        </p:spPr>
      </p:pic>
      <p:pic>
        <p:nvPicPr>
          <p:cNvPr id="3" name="Picture 3" descr="E:\数据数据数据数据\2023 02 13补充数据\补充数据 ai excel word\FLC KAC 2.tif"/>
          <p:cNvPicPr>
            <a:picLocks noChangeAspect="1" noChangeArrowheads="1"/>
          </p:cNvPicPr>
          <p:nvPr/>
        </p:nvPicPr>
        <p:blipFill>
          <a:blip r:embed="rId4" cstate="print">
            <a:lum contrast="-10000"/>
          </a:blip>
          <a:srcRect/>
          <a:stretch>
            <a:fillRect/>
          </a:stretch>
        </p:blipFill>
        <p:spPr bwMode="auto">
          <a:xfrm>
            <a:off x="755576" y="3573016"/>
            <a:ext cx="3419475" cy="2554287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a </a:t>
            </a:r>
            <a:r>
              <a:rPr lang="en-GB" altLang="zh-CN" sz="1200" dirty="0" err="1" smtClean="0"/>
              <a:t>Acetylation</a:t>
            </a:r>
            <a:r>
              <a:rPr lang="en-GB" altLang="zh-CN" sz="1200" dirty="0" smtClean="0"/>
              <a:t> analysis of Isw1 </a:t>
            </a:r>
            <a:endParaRPr lang="en-GB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092280" y="623731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P:Isw1-Flag</a:t>
            </a:r>
            <a:endParaRPr lang="en-GB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389887" y="1815999"/>
            <a:ext cx="7745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715569" y="1892943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75609" y="1910524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901396" y="1892943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 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051720" y="170080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088031" y="1423809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779912" y="2420888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Kac</a:t>
            </a:r>
            <a:endParaRPr lang="en-US" sz="1200" dirty="0" smtClean="0"/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15" name="右大括号 14"/>
          <p:cNvSpPr/>
          <p:nvPr/>
        </p:nvSpPr>
        <p:spPr>
          <a:xfrm>
            <a:off x="3275856" y="2348880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144931" y="1462506"/>
            <a:ext cx="7745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531993" y="1539451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892033" y="1539451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717820" y="1539451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 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868144" y="130011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904455" y="105273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524328" y="1977807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25" name="右大括号 24"/>
          <p:cNvSpPr/>
          <p:nvPr/>
        </p:nvSpPr>
        <p:spPr>
          <a:xfrm>
            <a:off x="7092280" y="1948190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050" name="Picture 2" descr="E:\数据数据数据数据\2023 02 13补充数据\补充数据 ai excel word\FLC FLAG 3.tif"/>
          <p:cNvPicPr>
            <a:picLocks noChangeAspect="1" noChangeArrowheads="1"/>
          </p:cNvPicPr>
          <p:nvPr/>
        </p:nvPicPr>
        <p:blipFill>
          <a:blip r:embed="rId5" cstate="print">
            <a:lum contrast="-10000"/>
          </a:blip>
          <a:srcRect/>
          <a:stretch>
            <a:fillRect/>
          </a:stretch>
        </p:blipFill>
        <p:spPr bwMode="auto">
          <a:xfrm>
            <a:off x="4281723" y="3571303"/>
            <a:ext cx="3421720" cy="2556000"/>
          </a:xfrm>
          <a:prstGeom prst="rect">
            <a:avLst/>
          </a:prstGeom>
          <a:noFill/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33903" y="3897683"/>
            <a:ext cx="7745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859585" y="397462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219625" y="3992208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45412" y="397462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 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195736" y="3782492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232047" y="350549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923928" y="4502572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Kac</a:t>
            </a:r>
            <a:endParaRPr lang="en-US" sz="1200" dirty="0" smtClean="0"/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38" name="右大括号 37"/>
          <p:cNvSpPr/>
          <p:nvPr/>
        </p:nvSpPr>
        <p:spPr>
          <a:xfrm>
            <a:off x="3419872" y="4430564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144931" y="3879420"/>
            <a:ext cx="7745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531993" y="395636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892033" y="395636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717820" y="395636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  FL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868144" y="3717032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904455" y="346965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524328" y="4394721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46" name="右大括号 45"/>
          <p:cNvSpPr/>
          <p:nvPr/>
        </p:nvSpPr>
        <p:spPr>
          <a:xfrm>
            <a:off x="7092280" y="4365104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332656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b </a:t>
            </a:r>
            <a:r>
              <a:rPr lang="en-GB" altLang="zh-CN" sz="1200" dirty="0" err="1" smtClean="0"/>
              <a:t>Acetylation</a:t>
            </a:r>
            <a:r>
              <a:rPr lang="en-GB" altLang="zh-CN" sz="1200" dirty="0" smtClean="0"/>
              <a:t> analysis of Isw1 </a:t>
            </a:r>
            <a:endParaRPr lang="en-GB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pic>
        <p:nvPicPr>
          <p:cNvPr id="4" name="图片 3" descr="Figure 3b isw1 Kac raw data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rcRect l="23156" t="7038" r="13692" b="36621"/>
          <a:stretch>
            <a:fillRect/>
          </a:stretch>
        </p:blipFill>
        <p:spPr>
          <a:xfrm>
            <a:off x="467544" y="2060848"/>
            <a:ext cx="3780000" cy="2520000"/>
          </a:xfrm>
          <a:prstGeom prst="rect">
            <a:avLst/>
          </a:prstGeom>
        </p:spPr>
      </p:pic>
      <p:pic>
        <p:nvPicPr>
          <p:cNvPr id="5" name="图片 4" descr="Figure 3b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rcRect l="23156" t="14363" r="22112" b="36621"/>
          <a:stretch>
            <a:fillRect/>
          </a:stretch>
        </p:blipFill>
        <p:spPr>
          <a:xfrm>
            <a:off x="4355976" y="2060848"/>
            <a:ext cx="3765581" cy="252000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1403648" y="3429000"/>
            <a:ext cx="1296144" cy="2880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148487" y="2860115"/>
            <a:ext cx="8465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222141" y="2973063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829388" y="2990644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499545" y="2973063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558292" y="2708920"/>
            <a:ext cx="12135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1691680" y="2420888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347864" y="3284984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Kac</a:t>
            </a:r>
            <a:endParaRPr lang="en-US" sz="1200" dirty="0" smtClean="0"/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14" name="右大括号 13"/>
          <p:cNvSpPr/>
          <p:nvPr/>
        </p:nvSpPr>
        <p:spPr>
          <a:xfrm>
            <a:off x="2987824" y="3284984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2757992" y="3573016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5652120" y="3789040"/>
            <a:ext cx="1656184" cy="2880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697396" y="3088543"/>
            <a:ext cx="8217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634198" y="318908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324081" y="318908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933844" y="318908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970349" y="2949754"/>
            <a:ext cx="1193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228184" y="2647945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8172400" y="3645024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24" name="右大括号 23"/>
          <p:cNvSpPr/>
          <p:nvPr/>
        </p:nvSpPr>
        <p:spPr>
          <a:xfrm>
            <a:off x="7668344" y="3645024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5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7380312" y="3861048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092280" y="465313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P:Isw1-Flag</a:t>
            </a:r>
            <a:endParaRPr lang="en-GB" sz="12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E:\数据数据数据数据\2023 02 13补充数据\wb\KAC WB\5fc\flag 1.tif"/>
          <p:cNvPicPr>
            <a:picLocks noChangeAspect="1" noChangeArrowheads="1"/>
          </p:cNvPicPr>
          <p:nvPr/>
        </p:nvPicPr>
        <p:blipFill>
          <a:blip r:embed="rId2" cstate="print">
            <a:lum contrast="-10000"/>
          </a:blip>
          <a:srcRect/>
          <a:stretch>
            <a:fillRect/>
          </a:stretch>
        </p:blipFill>
        <p:spPr bwMode="auto">
          <a:xfrm>
            <a:off x="4421633" y="836712"/>
            <a:ext cx="3606751" cy="2520000"/>
          </a:xfrm>
          <a:prstGeom prst="rect">
            <a:avLst/>
          </a:prstGeom>
          <a:noFill/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332656"/>
            <a:ext cx="2545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b </a:t>
            </a:r>
            <a:r>
              <a:rPr lang="en-GB" altLang="zh-CN" sz="1200" dirty="0" err="1" smtClean="0"/>
              <a:t>Acetylation</a:t>
            </a:r>
            <a:r>
              <a:rPr lang="en-GB" altLang="zh-CN" sz="1200" dirty="0" smtClean="0"/>
              <a:t> analysis of Isw1 </a:t>
            </a:r>
            <a:endParaRPr lang="en-GB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pic>
        <p:nvPicPr>
          <p:cNvPr id="1026" name="Picture 2" descr="E:\数据数据数据数据\2023 02 13补充数据\wb\KAC WB\5fc\flag 3.tif"/>
          <p:cNvPicPr>
            <a:picLocks noChangeAspect="1" noChangeArrowheads="1"/>
          </p:cNvPicPr>
          <p:nvPr/>
        </p:nvPicPr>
        <p:blipFill>
          <a:blip r:embed="rId3" cstate="print">
            <a:lum contrast="-10000"/>
          </a:blip>
          <a:srcRect/>
          <a:stretch>
            <a:fillRect/>
          </a:stretch>
        </p:blipFill>
        <p:spPr bwMode="auto">
          <a:xfrm>
            <a:off x="4421632" y="3428999"/>
            <a:ext cx="3600000" cy="2689136"/>
          </a:xfrm>
          <a:prstGeom prst="rect">
            <a:avLst/>
          </a:prstGeom>
          <a:noFill/>
        </p:spPr>
      </p:pic>
      <p:pic>
        <p:nvPicPr>
          <p:cNvPr id="1027" name="Picture 3" descr="E:\数据数据数据数据\2023 02 13补充数据\wb\KAC WB\5fc\kac 3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84225" y="3428999"/>
            <a:ext cx="3419475" cy="2554287"/>
          </a:xfrm>
          <a:prstGeom prst="rect">
            <a:avLst/>
          </a:prstGeom>
          <a:noFill/>
        </p:spPr>
      </p:pic>
      <p:pic>
        <p:nvPicPr>
          <p:cNvPr id="1028" name="Picture 4" descr="E:\数据数据数据数据\2023 02 13补充数据\wb\KAC WB\5fc\kac 2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27584" y="836712"/>
            <a:ext cx="3419475" cy="2554287"/>
          </a:xfrm>
          <a:prstGeom prst="rect">
            <a:avLst/>
          </a:prstGeom>
          <a:noFill/>
        </p:spPr>
      </p:pic>
      <p:sp>
        <p:nvSpPr>
          <p:cNvPr id="8" name="矩形 7"/>
          <p:cNvSpPr/>
          <p:nvPr/>
        </p:nvSpPr>
        <p:spPr>
          <a:xfrm>
            <a:off x="2123728" y="1844824"/>
            <a:ext cx="864096" cy="2880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08527" y="1275939"/>
            <a:ext cx="8465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829388" y="138888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261436" y="1406468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45412" y="138888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846324" y="1124744"/>
            <a:ext cx="12135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1979712" y="83671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635896" y="1700808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Kac</a:t>
            </a:r>
            <a:endParaRPr lang="en-US" sz="1200" dirty="0" smtClean="0"/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16" name="右大括号 15"/>
          <p:cNvSpPr/>
          <p:nvPr/>
        </p:nvSpPr>
        <p:spPr>
          <a:xfrm>
            <a:off x="3275856" y="1700808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7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3046024" y="1988840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5580112" y="1628800"/>
            <a:ext cx="1584176" cy="2880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511569" y="928303"/>
            <a:ext cx="8217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448371" y="102884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138254" y="102884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748017" y="1028847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784522" y="789514"/>
            <a:ext cx="1193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042357" y="487705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8028384" y="1556792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26" name="右大括号 25"/>
          <p:cNvSpPr/>
          <p:nvPr/>
        </p:nvSpPr>
        <p:spPr>
          <a:xfrm>
            <a:off x="7524328" y="1556792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7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7236296" y="1772816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876256" y="616530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P:Isw1-Flag</a:t>
            </a:r>
            <a:endParaRPr lang="en-GB" sz="1200" dirty="0"/>
          </a:p>
        </p:txBody>
      </p:sp>
      <p:sp>
        <p:nvSpPr>
          <p:cNvPr id="29" name="矩形 28"/>
          <p:cNvSpPr/>
          <p:nvPr/>
        </p:nvSpPr>
        <p:spPr>
          <a:xfrm>
            <a:off x="2123728" y="4437112"/>
            <a:ext cx="864096" cy="2880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80535" y="3868227"/>
            <a:ext cx="8465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829388" y="398117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261436" y="3998756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03601" y="3981175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846324" y="3789040"/>
            <a:ext cx="12135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1979712" y="3501008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635896" y="4365104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Kac</a:t>
            </a:r>
            <a:endParaRPr lang="en-US" sz="1200" dirty="0" smtClean="0"/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37" name="右大括号 36"/>
          <p:cNvSpPr/>
          <p:nvPr/>
        </p:nvSpPr>
        <p:spPr>
          <a:xfrm>
            <a:off x="3275856" y="4365104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3046024" y="4653136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矩形 38"/>
          <p:cNvSpPr/>
          <p:nvPr/>
        </p:nvSpPr>
        <p:spPr>
          <a:xfrm>
            <a:off x="5724128" y="4653136"/>
            <a:ext cx="1080120" cy="2880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305419" y="3898212"/>
            <a:ext cx="8217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- 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448371" y="3998756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964041" y="3998756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TSA/NAM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676009" y="3998756"/>
            <a:ext cx="77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400 5-FC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784522" y="3759423"/>
            <a:ext cx="1193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042357" y="345761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668344" y="4581128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47" name="右大括号 46"/>
          <p:cNvSpPr/>
          <p:nvPr/>
        </p:nvSpPr>
        <p:spPr>
          <a:xfrm>
            <a:off x="7164288" y="4581128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6876256" y="4797152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47" descr="histone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4644008" y="1916832"/>
            <a:ext cx="2682972" cy="1877298"/>
          </a:xfrm>
          <a:prstGeom prst="rect">
            <a:avLst/>
          </a:prstGeom>
        </p:spPr>
      </p:pic>
      <p:pic>
        <p:nvPicPr>
          <p:cNvPr id="3" name="图片 2" descr="Figure 3e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755576" y="1844824"/>
            <a:ext cx="3420687" cy="25561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7739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e </a:t>
            </a:r>
            <a:r>
              <a:rPr lang="en-GB" altLang="zh-CN" sz="1200" dirty="0" smtClean="0"/>
              <a:t> Isw1 mutation strain constructs</a:t>
            </a:r>
            <a:endParaRPr lang="en-GB" altLang="zh-CN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6" name="矩形 5"/>
          <p:cNvSpPr/>
          <p:nvPr/>
        </p:nvSpPr>
        <p:spPr>
          <a:xfrm>
            <a:off x="2015208" y="2852936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051720" y="2143889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8" name="右大括号 7"/>
          <p:cNvSpPr/>
          <p:nvPr/>
        </p:nvSpPr>
        <p:spPr>
          <a:xfrm>
            <a:off x="3203848" y="2708920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2879304" y="2996952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3563888" y="2708920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cxnSp>
        <p:nvCxnSpPr>
          <p:cNvPr id="1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051720" y="242088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009408" y="2577018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183621" y="2577018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471653" y="2577018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5148064" y="3140968"/>
            <a:ext cx="1584176" cy="36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436096" y="393305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7" name="右大括号 16"/>
          <p:cNvSpPr/>
          <p:nvPr/>
        </p:nvSpPr>
        <p:spPr>
          <a:xfrm>
            <a:off x="6876256" y="2564904"/>
            <a:ext cx="288032" cy="86409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6732240" y="328498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308304" y="2780928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cxnSp>
        <p:nvCxnSpPr>
          <p:cNvPr id="20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436096" y="3933056"/>
            <a:ext cx="122413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321776" y="3657140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753824" y="3657140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288077" y="3657140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ure 3f histone raw data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4646561" y="1916833"/>
            <a:ext cx="3237807" cy="2419004"/>
          </a:xfrm>
          <a:prstGeom prst="rect">
            <a:avLst/>
          </a:prstGeom>
        </p:spPr>
      </p:pic>
      <p:pic>
        <p:nvPicPr>
          <p:cNvPr id="3" name="图片 2" descr="Figure 3f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611560" y="1988841"/>
            <a:ext cx="3237807" cy="24190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7739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f </a:t>
            </a:r>
            <a:r>
              <a:rPr lang="en-GB" altLang="zh-CN" sz="1200" dirty="0" smtClean="0"/>
              <a:t> Isw1 mutation strain constructs</a:t>
            </a:r>
            <a:endParaRPr lang="en-GB" altLang="zh-CN" sz="1200" dirty="0"/>
          </a:p>
        </p:txBody>
      </p:sp>
      <p:sp>
        <p:nvSpPr>
          <p:cNvPr id="5" name="矩形 4"/>
          <p:cNvSpPr/>
          <p:nvPr/>
        </p:nvSpPr>
        <p:spPr>
          <a:xfrm>
            <a:off x="2627784" y="3057928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627784" y="2348881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7" name="右大括号 6"/>
          <p:cNvSpPr/>
          <p:nvPr/>
        </p:nvSpPr>
        <p:spPr>
          <a:xfrm>
            <a:off x="3816424" y="2913912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3491880" y="320194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4176464" y="2913912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cxnSp>
        <p:nvCxnSpPr>
          <p:cNvPr id="10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664296" y="2564905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43661" y="2782012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693194" y="271552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879020" y="271552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017230" y="267951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6804248" y="3057928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6804248" y="2348881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7" name="右大括号 16"/>
          <p:cNvSpPr/>
          <p:nvPr/>
        </p:nvSpPr>
        <p:spPr>
          <a:xfrm>
            <a:off x="7884368" y="2913912"/>
            <a:ext cx="288032" cy="50405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8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7668344" y="320194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8064896" y="2913912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cxnSp>
        <p:nvCxnSpPr>
          <p:cNvPr id="20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840760" y="2564905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720125" y="2782012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869658" y="271552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055484" y="271552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193694" y="267951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076056" y="191683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26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112568" y="2132856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4991933" y="2349963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141466" y="2283471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327292" y="2283471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465502" y="2247467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899592" y="220486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32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936104" y="242088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815469" y="2637995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965002" y="2571503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150828" y="2571503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289038" y="2535499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igure supplement 3e histone raw data.ti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4860032" y="1916832"/>
            <a:ext cx="3203448" cy="2392680"/>
          </a:xfrm>
          <a:prstGeom prst="rect">
            <a:avLst/>
          </a:prstGeom>
        </p:spPr>
      </p:pic>
      <p:pic>
        <p:nvPicPr>
          <p:cNvPr id="5" name="图片 4" descr="Figure supplement 3e isw1-flag raw data.ti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971600" y="1916832"/>
            <a:ext cx="3203448" cy="23926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68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igure </a:t>
            </a:r>
            <a:r>
              <a:rPr lang="en-US" altLang="zh-CN" sz="1200" dirty="0" smtClean="0"/>
              <a:t>f</a:t>
            </a:r>
            <a:r>
              <a:rPr lang="en-GB" sz="1200" dirty="0" smtClean="0"/>
              <a:t> </a:t>
            </a:r>
            <a:r>
              <a:rPr lang="en-GB" altLang="zh-CN" sz="1200" dirty="0" smtClean="0"/>
              <a:t> </a:t>
            </a:r>
            <a:r>
              <a:rPr lang="en-GB" altLang="zh-CN" sz="1200" dirty="0" smtClean="0"/>
              <a:t>Isw1 mutation strain constructs</a:t>
            </a:r>
            <a:endParaRPr lang="en-GB" altLang="zh-CN" sz="1200" dirty="0"/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2195736" y="141277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sp>
        <p:nvSpPr>
          <p:cNvPr id="10" name="右大括号 9"/>
          <p:cNvSpPr/>
          <p:nvPr/>
        </p:nvSpPr>
        <p:spPr>
          <a:xfrm>
            <a:off x="3995936" y="2060848"/>
            <a:ext cx="288032" cy="1800200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4283968" y="2751311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cxnSp>
        <p:nvCxnSpPr>
          <p:cNvPr id="13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232248" y="1628800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111613" y="1845907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261146" y="1779415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446972" y="1779415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585182" y="1743411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右大括号 19"/>
          <p:cNvSpPr/>
          <p:nvPr/>
        </p:nvSpPr>
        <p:spPr>
          <a:xfrm>
            <a:off x="7812360" y="2132856"/>
            <a:ext cx="288032" cy="165618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8136904" y="2708920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1259632" y="1513397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36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296144" y="1729421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175509" y="1946528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325042" y="1880036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510868" y="1880036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649078" y="1844032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3131840" y="1513397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42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3168352" y="1729421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047717" y="1946528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197250" y="1880036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383076" y="1880036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521286" y="1844032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6084168" y="162880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48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120680" y="1844824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000045" y="2061931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149578" y="199543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335404" y="199543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473614" y="1959435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5148064" y="165741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54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184576" y="1873437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063941" y="2090544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213474" y="202405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399300" y="202405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537510" y="1988048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7020272" y="162880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60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7056784" y="1844824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936149" y="2061931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085682" y="199543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271508" y="199543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409718" y="1959435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Q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1331640" y="393305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66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331640" y="3933056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247517" y="3397720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397050" y="346421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582876" y="346421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1721086" y="350021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2267744" y="3944089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72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267744" y="3944089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183621" y="3408753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333154" y="3475245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518980" y="3475245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2657190" y="3511249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3203848" y="397645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78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3203848" y="3976452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119725" y="3441116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269258" y="3507608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455084" y="3507608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3593294" y="3543612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5148064" y="426448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84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148064" y="4264484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063941" y="3729148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213474" y="379564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399300" y="379564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5537510" y="3831644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6084168" y="419247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90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084168" y="4192476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000045" y="3657140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149578" y="372363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335404" y="372363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6473614" y="375963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7092280" y="416011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96" name="Straight Connector 82">
            <a:extLst>
              <a:ext uri="{FF2B5EF4-FFF2-40B4-BE49-F238E27FC236}">
                <a16:creationId xmlns="" xmlns:a16="http://schemas.microsoft.com/office/drawing/2014/main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7092280" y="4160113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008157" y="3624777"/>
            <a:ext cx="414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157690" y="369126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89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343516" y="369126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97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="" xmlns:a16="http://schemas.microsoft.com/office/drawing/2014/main" id="{30B48CE1-1A47-4369-953D-0FB94087D445}"/>
              </a:ext>
            </a:extLst>
          </p:cNvPr>
          <p:cNvSpPr txBox="1"/>
          <p:nvPr/>
        </p:nvSpPr>
        <p:spPr>
          <a:xfrm rot="16200000">
            <a:off x="7481726" y="3727273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K113R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ure 3g histone raw data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4860032" y="2204864"/>
            <a:ext cx="3420687" cy="2556164"/>
          </a:xfrm>
          <a:prstGeom prst="rect">
            <a:avLst/>
          </a:prstGeom>
        </p:spPr>
      </p:pic>
      <p:pic>
        <p:nvPicPr>
          <p:cNvPr id="3" name="图片 2" descr="Figure 3g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611560" y="2204864"/>
            <a:ext cx="3420687" cy="25561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375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g </a:t>
            </a:r>
            <a:r>
              <a:rPr lang="en-GB" altLang="zh-CN" sz="1200" dirty="0" smtClean="0"/>
              <a:t> Isw1 WT protein stability</a:t>
            </a:r>
            <a:endParaRPr lang="en-GB" altLang="zh-CN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6" name="矩形 5"/>
          <p:cNvSpPr/>
          <p:nvPr/>
        </p:nvSpPr>
        <p:spPr>
          <a:xfrm>
            <a:off x="2843808" y="2481863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右大括号 7"/>
          <p:cNvSpPr/>
          <p:nvPr/>
        </p:nvSpPr>
        <p:spPr>
          <a:xfrm>
            <a:off x="3960440" y="2337846"/>
            <a:ext cx="288032" cy="188324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3635896" y="256490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4283968" y="3068960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16" name="矩形 15"/>
          <p:cNvSpPr/>
          <p:nvPr/>
        </p:nvSpPr>
        <p:spPr>
          <a:xfrm>
            <a:off x="6948264" y="2636912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右大括号 17"/>
          <p:cNvSpPr/>
          <p:nvPr/>
        </p:nvSpPr>
        <p:spPr>
          <a:xfrm>
            <a:off x="8028384" y="2564904"/>
            <a:ext cx="288032" cy="1728192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9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7740352" y="2780928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8280920" y="3140968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1115616" y="148478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3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115616" y="170080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/>
          <p:cNvSpPr/>
          <p:nvPr/>
        </p:nvSpPr>
        <p:spPr>
          <a:xfrm>
            <a:off x="110213" y="1916832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84983" y="1815419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078820" y="192343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222837" y="1851422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433055" y="188742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915815" y="148478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57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915815" y="170080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矩形 57"/>
          <p:cNvSpPr/>
          <p:nvPr/>
        </p:nvSpPr>
        <p:spPr>
          <a:xfrm>
            <a:off x="1910412" y="1916832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85182" y="1815419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837210" y="192343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981226" y="1851422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233254" y="188742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220072" y="148478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64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220072" y="1700808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矩形 64"/>
          <p:cNvSpPr/>
          <p:nvPr/>
        </p:nvSpPr>
        <p:spPr>
          <a:xfrm>
            <a:off x="4214669" y="1916832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4889439" y="1815419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213475" y="1923430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327293" y="1851422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537511" y="1887426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017563" y="155679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7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7017563" y="1772817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矩形 71"/>
          <p:cNvSpPr/>
          <p:nvPr/>
        </p:nvSpPr>
        <p:spPr>
          <a:xfrm>
            <a:off x="6012160" y="1988841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686930" y="1887428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010966" y="199543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124784" y="1923431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335002" y="1959435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971600" y="4437112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78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971600" y="4365104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矩形 78"/>
          <p:cNvSpPr/>
          <p:nvPr/>
        </p:nvSpPr>
        <p:spPr>
          <a:xfrm>
            <a:off x="0" y="4005064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76972" y="3896262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862929" y="3896131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078953" y="3896131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218653" y="3896841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987824" y="4408495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85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987824" y="4336487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矩形 85"/>
          <p:cNvSpPr/>
          <p:nvPr/>
        </p:nvSpPr>
        <p:spPr>
          <a:xfrm>
            <a:off x="2016224" y="3976447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693196" y="3867645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879153" y="3867514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095177" y="3867514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234877" y="3868224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327576" y="462452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92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327576" y="4552512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矩形 92"/>
          <p:cNvSpPr/>
          <p:nvPr/>
        </p:nvSpPr>
        <p:spPr>
          <a:xfrm>
            <a:off x="4355976" y="4192472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032948" y="4083670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218905" y="4083539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434929" y="4083539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574629" y="4084249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271792" y="4592161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99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7271792" y="4520153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矩形 99"/>
          <p:cNvSpPr/>
          <p:nvPr/>
        </p:nvSpPr>
        <p:spPr>
          <a:xfrm>
            <a:off x="6300192" y="4160113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977164" y="4051311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163121" y="4051180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379145" y="4051180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518845" y="4051890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ure 3h histone raw data.tif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4716016" y="2060848"/>
            <a:ext cx="3420687" cy="2556164"/>
          </a:xfrm>
          <a:prstGeom prst="rect">
            <a:avLst/>
          </a:prstGeom>
        </p:spPr>
      </p:pic>
      <p:pic>
        <p:nvPicPr>
          <p:cNvPr id="3" name="图片 2" descr="Figure 3h isw1-flag raw data.tif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647257" y="2060848"/>
            <a:ext cx="3420687" cy="25561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F1B918-5CE1-4D79-8A6B-83E84F132F9D}"/>
              </a:ext>
            </a:extLst>
          </p:cNvPr>
          <p:cNvSpPr txBox="1"/>
          <p:nvPr/>
        </p:nvSpPr>
        <p:spPr>
          <a:xfrm>
            <a:off x="179512" y="271681"/>
            <a:ext cx="2504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5</a:t>
            </a:r>
            <a:r>
              <a:rPr lang="en-US" altLang="zh-CN" sz="1200" dirty="0" smtClean="0"/>
              <a:t>h</a:t>
            </a:r>
            <a:r>
              <a:rPr lang="en-GB" sz="1200" dirty="0" smtClean="0"/>
              <a:t> </a:t>
            </a:r>
            <a:r>
              <a:rPr lang="en-GB" altLang="zh-CN" sz="1200" dirty="0" smtClean="0"/>
              <a:t> Isw1 K97Q protein stability</a:t>
            </a:r>
            <a:endParaRPr lang="en-GB" altLang="zh-CN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72" name="矩形 71"/>
          <p:cNvSpPr/>
          <p:nvPr/>
        </p:nvSpPr>
        <p:spPr>
          <a:xfrm>
            <a:off x="2841099" y="2492896"/>
            <a:ext cx="792088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3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3633187" y="2575937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4281259" y="3079993"/>
            <a:ext cx="5040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lag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75" name="矩形 74"/>
          <p:cNvSpPr/>
          <p:nvPr/>
        </p:nvSpPr>
        <p:spPr>
          <a:xfrm>
            <a:off x="6876256" y="2647945"/>
            <a:ext cx="861387" cy="2049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6" name="Straight Arrow Connector 8">
            <a:extLst>
              <a:ext uri="{FF2B5EF4-FFF2-40B4-BE49-F238E27FC236}">
                <a16:creationId xmlns:a16="http://schemas.microsoft.com/office/drawing/2014/main" xmlns="" id="{73FC063C-0A41-450B-9963-EE5D94FBB617}"/>
              </a:ext>
            </a:extLst>
          </p:cNvPr>
          <p:cNvCxnSpPr/>
          <p:nvPr/>
        </p:nvCxnSpPr>
        <p:spPr>
          <a:xfrm flipH="1">
            <a:off x="7737643" y="2791961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8278211" y="3152001"/>
            <a:ext cx="82758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Histone</a:t>
            </a:r>
            <a:r>
              <a:rPr lang="en-US" sz="1200" dirty="0" smtClean="0"/>
              <a:t> 3</a:t>
            </a:r>
          </a:p>
          <a:p>
            <a:r>
              <a:rPr lang="en-US" sz="1200" dirty="0" err="1" smtClean="0"/>
              <a:t>Ab</a:t>
            </a:r>
            <a:endParaRPr lang="en-GB" sz="12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1043609" y="158540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79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1043609" y="1801430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矩形 79"/>
          <p:cNvSpPr/>
          <p:nvPr/>
        </p:nvSpPr>
        <p:spPr>
          <a:xfrm>
            <a:off x="38206" y="2017454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12976" y="1916041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006813" y="202405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150830" y="1952044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361048" y="1988048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843808" y="158540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86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843808" y="1801430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矩形 86"/>
          <p:cNvSpPr/>
          <p:nvPr/>
        </p:nvSpPr>
        <p:spPr>
          <a:xfrm>
            <a:off x="1838405" y="2017454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513175" y="1916041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765203" y="2024052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909219" y="1952044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161247" y="1988048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145355" y="165741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93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145355" y="1873437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矩形 93"/>
          <p:cNvSpPr/>
          <p:nvPr/>
        </p:nvSpPr>
        <p:spPr>
          <a:xfrm>
            <a:off x="4139952" y="2089461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4814722" y="1988048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138758" y="2096059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252576" y="2024051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462794" y="2060055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014854" y="156782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100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6942846" y="1945446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矩形 100"/>
          <p:cNvSpPr/>
          <p:nvPr/>
        </p:nvSpPr>
        <p:spPr>
          <a:xfrm>
            <a:off x="5937443" y="2161470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612213" y="2060057"/>
            <a:ext cx="763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936249" y="2168068"/>
            <a:ext cx="547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050067" y="2096060"/>
            <a:ext cx="69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260285" y="2132064"/>
            <a:ext cx="6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971600" y="4592161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107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971600" y="4520153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矩形 107"/>
          <p:cNvSpPr/>
          <p:nvPr/>
        </p:nvSpPr>
        <p:spPr>
          <a:xfrm>
            <a:off x="0" y="4160113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76972" y="4051311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862929" y="4051180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078953" y="4051180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1218653" y="4051890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2987824" y="456354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114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2987824" y="4491536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矩形 114"/>
          <p:cNvSpPr/>
          <p:nvPr/>
        </p:nvSpPr>
        <p:spPr>
          <a:xfrm>
            <a:off x="2016224" y="4131496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693196" y="4022694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2879153" y="4022563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095177" y="4022563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3234877" y="4023273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5183560" y="488019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121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5183560" y="4808185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矩形 121"/>
          <p:cNvSpPr/>
          <p:nvPr/>
        </p:nvSpPr>
        <p:spPr>
          <a:xfrm>
            <a:off x="4211960" y="4448145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4888932" y="4339343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074889" y="4339212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290913" y="4339212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5430613" y="4339922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768E557C-BB6C-4E51-B3E1-1EE4ECB63A0D}"/>
              </a:ext>
            </a:extLst>
          </p:cNvPr>
          <p:cNvSpPr txBox="1"/>
          <p:nvPr/>
        </p:nvSpPr>
        <p:spPr>
          <a:xfrm>
            <a:off x="7020272" y="4952201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w1-Flag</a:t>
            </a:r>
            <a:endParaRPr lang="en-GB" sz="1200" dirty="0"/>
          </a:p>
        </p:txBody>
      </p:sp>
      <p:cxnSp>
        <p:nvCxnSpPr>
          <p:cNvPr id="128" name="Straight Connector 82">
            <a:extLst>
              <a:ext uri="{FF2B5EF4-FFF2-40B4-BE49-F238E27FC236}">
                <a16:creationId xmlns:a16="http://schemas.microsoft.com/office/drawing/2014/main" xmlns="" id="{B49EEE9D-03DD-4FE1-BCD8-A501D4B4EF99}"/>
              </a:ext>
            </a:extLst>
          </p:cNvPr>
          <p:cNvCxnSpPr>
            <a:cxnSpLocks/>
          </p:cNvCxnSpPr>
          <p:nvPr/>
        </p:nvCxnSpPr>
        <p:spPr>
          <a:xfrm>
            <a:off x="7020272" y="4880193"/>
            <a:ext cx="7920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矩形 128"/>
          <p:cNvSpPr/>
          <p:nvPr/>
        </p:nvSpPr>
        <p:spPr>
          <a:xfrm>
            <a:off x="6048672" y="4520153"/>
            <a:ext cx="10054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CHX(200 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  <a:sym typeface="Symbol"/>
              </a:rPr>
              <a:t></a:t>
            </a:r>
            <a:r>
              <a:rPr lang="en-GB" altLang="zh-CN" sz="1000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725644" y="4411351"/>
            <a:ext cx="691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No CHX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6911601" y="4411220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5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127625" y="4411220"/>
            <a:ext cx="691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3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30B48CE1-1A47-4369-953D-0FB94087D445}"/>
              </a:ext>
            </a:extLst>
          </p:cNvPr>
          <p:cNvSpPr txBox="1"/>
          <p:nvPr/>
        </p:nvSpPr>
        <p:spPr>
          <a:xfrm rot="16200000">
            <a:off x="7267325" y="4411930"/>
            <a:ext cx="6912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60mins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右大括号 133"/>
          <p:cNvSpPr/>
          <p:nvPr/>
        </p:nvSpPr>
        <p:spPr>
          <a:xfrm>
            <a:off x="3960440" y="2337846"/>
            <a:ext cx="288032" cy="188324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5" name="右大括号 134"/>
          <p:cNvSpPr/>
          <p:nvPr/>
        </p:nvSpPr>
        <p:spPr>
          <a:xfrm>
            <a:off x="7956376" y="2492896"/>
            <a:ext cx="288032" cy="1883241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9</TotalTime>
  <Words>904</Words>
  <Application>Microsoft Office PowerPoint</Application>
  <PresentationFormat>全屏显示(4:3)</PresentationFormat>
  <Paragraphs>373</Paragraphs>
  <Slides>1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2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Windows 用户</cp:lastModifiedBy>
  <cp:revision>18</cp:revision>
  <dcterms:created xsi:type="dcterms:W3CDTF">2022-12-24T08:38:34Z</dcterms:created>
  <dcterms:modified xsi:type="dcterms:W3CDTF">2023-10-24T11:30:26Z</dcterms:modified>
</cp:coreProperties>
</file>